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86AF3-C1BA-43F8-96FA-FF6642DA6E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84D8F-C02C-40E8-949C-62AF63AEC2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E288C-3CD7-4507-9325-CD0BFE29D3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A54A8-72EA-40D2-B0CB-F341B8BA70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997C5-766E-47B1-BFC6-171782CACB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05E71-F319-4F69-9D80-71B58AFA48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D4719-1BDE-4129-A236-09F617F0EF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429FC-2E71-4C69-BC46-D75D96E8AD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0D984-00FF-44EF-9F39-983DB9A925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DDD49-2800-4840-AC4F-DA596E41EE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06439-6319-4E66-903E-A16F5AE2B9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F3D2C-16EF-402B-A54B-4123551FAD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612956-0054-4950-8B43-4BB2C2BECD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076400" y="1415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305000" y="141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35040" y="14158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66880" y="141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995480" y="1415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225520" y="14158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455920" y="141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908440" y="141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87760" y="141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076400" y="159372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305000" y="15937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535040" y="15937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766880" y="15937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995480" y="15937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25520" y="15937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455920" y="159372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08440" y="159372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687760" y="15937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076400" y="177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05000" y="1774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35040" y="1774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66880" y="1774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995480" y="1774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225520" y="1774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455920" y="1774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908440" y="177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687760" y="177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076400" y="19540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305000" y="1954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535040" y="19540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766880" y="19540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995480" y="1954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225520" y="19540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455920" y="1954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908440" y="19540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687760" y="19540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076400" y="21337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305000" y="21337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535040" y="213372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766880" y="2133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995480" y="21337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225520" y="21337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455920" y="2133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908440" y="2133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687760" y="2133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076400" y="24955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305000" y="24955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35040" y="24955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766880" y="24955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995480" y="24955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225520" y="24955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455920" y="24955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908440" y="24955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687760" y="24955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076400" y="267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305000" y="2676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535040" y="26766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766880" y="2676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995480" y="267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225520" y="26766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455920" y="2676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908440" y="2676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687760" y="2676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076400" y="28544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305000" y="28544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535040" y="28544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766880" y="28544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995480" y="28544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225520" y="28544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455920" y="28544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908440" y="28544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687760" y="28544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076400" y="3035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305000" y="3035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535040" y="30351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766880" y="3035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995480" y="3035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225520" y="3035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455920" y="3035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908440" y="3035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687760" y="3035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076400" y="3214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305000" y="321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535040" y="32148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766880" y="3214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995480" y="321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225520" y="32148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455920" y="3214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908440" y="3214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687760" y="3214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076400" y="33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305000" y="33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535040" y="33973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766880" y="33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995480" y="33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225520" y="33973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455920" y="3397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908440" y="3397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687760" y="3397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076400" y="35766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305000" y="35766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535040" y="357660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766880" y="35766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995480" y="35766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225520" y="357660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455920" y="35766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908440" y="35766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687760" y="35766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076400" y="375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305000" y="375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535040" y="37558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766880" y="3755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995480" y="375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225520" y="37558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455920" y="375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908440" y="3755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687760" y="375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076400" y="39369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305000" y="39369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535040" y="39369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766880" y="39369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995480" y="39369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225520" y="39369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455920" y="39369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908440" y="39369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687760" y="39369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076400" y="12333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305000" y="1233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535040" y="12333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766880" y="1233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995480" y="12333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225520" y="12333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455920" y="1233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908440" y="12333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687760" y="12333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630360" y="1233360"/>
            <a:ext cx="18864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1-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701640" y="1593720"/>
            <a:ext cx="1890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701640" y="177480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701640" y="1954080"/>
            <a:ext cx="1890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701640" y="2133720"/>
            <a:ext cx="189000" cy="11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701640" y="24955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01640" y="267660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701640" y="285444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701640" y="303516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701640" y="321480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701640" y="33973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701640" y="357660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701640" y="375588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701640" y="393696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228680" y="1077840"/>
            <a:ext cx="1872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076400" y="2316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305000" y="23162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535040" y="23162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766880" y="2316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995480" y="2316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225520" y="23162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455920" y="23162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908440" y="23162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687760" y="2316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01640" y="231624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701640" y="141588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081080" y="431496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1311120" y="431496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1542960" y="431496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1771560" y="431496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001960" y="431496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232000" y="431496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462040" y="431496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914560" y="431496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2692440" y="431496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706320" y="4314960"/>
            <a:ext cx="190440" cy="1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231920" y="3978360"/>
            <a:ext cx="1872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081080" y="46162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311120" y="4616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1542960" y="4616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771560" y="461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001960" y="46162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232000" y="46162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462040" y="461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914560" y="461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692440" y="46162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635040" y="4616280"/>
            <a:ext cx="19044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2-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081080" y="47941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311120" y="47941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542960" y="47941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771560" y="4794120"/>
            <a:ext cx="18756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2001960" y="47941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232000" y="47941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462040" y="47941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914560" y="47941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2692440" y="47941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706320" y="4794120"/>
            <a:ext cx="190440" cy="11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081080" y="49766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311120" y="49766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542960" y="49766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1771560" y="49766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001960" y="49766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232000" y="49766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462040" y="49766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914560" y="49766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692440" y="49766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081080" y="51577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1311120" y="51577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1542960" y="51577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1771560" y="51577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2001960" y="51577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232000" y="51577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462040" y="51577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914560" y="51577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692440" y="51577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081080" y="53370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311120" y="53370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1542960" y="53370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1771560" y="53370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001960" y="53370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232000" y="53370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462040" y="53370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914560" y="53370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692440" y="53370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081080" y="5516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311120" y="55166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542960" y="5516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771560" y="55166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001960" y="5516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232000" y="55166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462040" y="5516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2914560" y="5516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2692440" y="55166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1081080" y="56959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1311120" y="5695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1542960" y="5695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1771560" y="56959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001960" y="56959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232000" y="56959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462040" y="5695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914560" y="5695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2692440" y="56959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1081080" y="60548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1311120" y="60548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1542960" y="60548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1771560" y="60548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001960" y="60548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2232000" y="60548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462040" y="60548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914560" y="60548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692440" y="60548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081080" y="623736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1311120" y="62373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1542960" y="623736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1771560" y="62373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2001960" y="623736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2232000" y="623736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2462040" y="623736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2914560" y="623736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2692440" y="623736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081080" y="64184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1311120" y="64184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542960" y="64184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771560" y="64184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001960" y="641844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232000" y="641844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462040" y="64184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914560" y="64184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692440" y="641844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081080" y="65977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311120" y="65977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1542960" y="65977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771560" y="65977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001960" y="65977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232000" y="65977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462040" y="65977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914560" y="65977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692440" y="65977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1081080" y="67802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1311120" y="67802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1542960" y="67802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1771560" y="67802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001960" y="67802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232000" y="67802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462040" y="67802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2914560" y="67802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692440" y="67802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1081080" y="69562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1311120" y="695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1542960" y="695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771560" y="6956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2001960" y="69562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2232000" y="69562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2462040" y="6956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2914560" y="6956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692440" y="69562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706320" y="4976640"/>
            <a:ext cx="1904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706320" y="5157720"/>
            <a:ext cx="19044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706320" y="5337000"/>
            <a:ext cx="1904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706320" y="5516640"/>
            <a:ext cx="1904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706320" y="5695920"/>
            <a:ext cx="19044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706320" y="6054840"/>
            <a:ext cx="190440" cy="11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706320" y="6237360"/>
            <a:ext cx="19044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706320" y="6418440"/>
            <a:ext cx="19044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706320" y="6597720"/>
            <a:ext cx="19044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706320" y="6780240"/>
            <a:ext cx="190440" cy="1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706320" y="6956280"/>
            <a:ext cx="19044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1081080" y="58784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1311120" y="58784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1542960" y="58784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1771560" y="58784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001960" y="58784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2232000" y="58784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2462040" y="58784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2914560" y="58784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2692440" y="58784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706320" y="5878440"/>
            <a:ext cx="190440" cy="1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1081080" y="41353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1311120" y="41353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1542960" y="41353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1771560" y="41353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001960" y="413532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2232000" y="41353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2462040" y="41353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2914560" y="41353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2692440" y="413532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706320" y="4135320"/>
            <a:ext cx="1904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1081080" y="7678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1311120" y="7678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1542960" y="7678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1773360" y="7678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2003400" y="7678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2232000" y="7678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2462040" y="7678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2916360" y="7678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2692440" y="7678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1081080" y="7858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1311120" y="78580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1542960" y="78580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1773360" y="7858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2003400" y="7858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2232000" y="78580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2462040" y="78580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2916360" y="78580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692440" y="78580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1081080" y="8040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1311120" y="8040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1542960" y="8040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1773360" y="8040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2003400" y="8040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2232000" y="8040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2462040" y="80406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2916360" y="8040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2692440" y="8040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1081080" y="7497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1311120" y="74977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1542960" y="749772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1773360" y="7497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2003400" y="74977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2232000" y="74977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2462040" y="74977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2916360" y="74977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2692440" y="74977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708120" y="7497720"/>
            <a:ext cx="188640" cy="11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708120" y="7678800"/>
            <a:ext cx="18864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708120" y="7858080"/>
            <a:ext cx="18864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708120" y="8040600"/>
            <a:ext cx="1886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1081080" y="713916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1311120" y="713916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1542960" y="713916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1773360" y="713916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2003400" y="713916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2232000" y="713916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2462040" y="713916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2916360" y="713916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2692440" y="713916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708120" y="7139160"/>
            <a:ext cx="188640" cy="1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1081080" y="7319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1311120" y="73198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1542960" y="73198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1773360" y="7319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2003400" y="7319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2232000" y="7319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2462040" y="73198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2916360" y="7319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2692440" y="7319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708120" y="7319880"/>
            <a:ext cx="18864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1081080" y="877716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1311120" y="877716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1542960" y="8777160"/>
            <a:ext cx="18756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1773360" y="87771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2003400" y="87771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2232000" y="877716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2462040" y="877716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2916360" y="877716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2692440" y="87771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630360" y="8777160"/>
            <a:ext cx="3474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1-10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1081080" y="8939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1311120" y="89391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542960" y="89391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1773360" y="8939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2003400" y="8939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2232000" y="8939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2462040" y="8939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2916360" y="8939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2692440" y="8939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665280" y="8948880"/>
            <a:ext cx="29664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4-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4100400" y="14097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4321080" y="140976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4541760" y="14097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4762440" y="140976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4981680" y="140976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5202360" y="140976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5421240" y="14097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5856120" y="140976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5640480" y="140976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3786120" y="140976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4100400" y="15908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4321080" y="15908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4541760" y="159084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4762440" y="15908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4981680" y="15908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5202360" y="15908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5421240" y="15908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5856120" y="15908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5640480" y="15908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3786120" y="159084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4100400" y="17701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4321080" y="17701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4541760" y="17701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4762440" y="17701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4981680" y="17701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5202360" y="17701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5421240" y="17701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5856120" y="17701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5640480" y="17701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3786120" y="17701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4100400" y="195120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4321080" y="195120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4541760" y="195120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4762440" y="195120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4981680" y="195120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5202360" y="195120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5421240" y="195120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5856120" y="195120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5640480" y="195120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4100400" y="2131920"/>
            <a:ext cx="18756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4321080" y="21319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4541760" y="21319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4762440" y="21319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4981680" y="21319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5202360" y="2131920"/>
            <a:ext cx="18720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5421240" y="213192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5856120" y="2131920"/>
            <a:ext cx="18756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5640480" y="213192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4100400" y="23097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4321080" y="23097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4541760" y="23097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4762440" y="23097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4981680" y="23097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5202360" y="23097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5421240" y="23097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5856120" y="23097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5640480" y="23097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4100400" y="2492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4321080" y="2492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4541760" y="2492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4762440" y="2492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4981680" y="24922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5202360" y="24922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5421240" y="2492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5856120" y="2492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5640480" y="24922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4100400" y="267012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4321080" y="26701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4541760" y="26701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4762440" y="26701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4981680" y="26701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5202360" y="26701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5421240" y="26701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5856120" y="267012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5640480" y="26701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4100400" y="30304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4321080" y="30304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4541760" y="30304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4762440" y="30304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4981680" y="30304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5202360" y="30304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5421240" y="30304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5856120" y="30304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5640480" y="30304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4100400" y="32115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4321080" y="32115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4541760" y="32115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4762440" y="32115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4981680" y="32115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5202360" y="32115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5421240" y="32115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5856120" y="32115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5640480" y="32115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4100400" y="3392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4321080" y="33926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4541760" y="3392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4762440" y="33926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4981680" y="3392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5202360" y="33926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5421240" y="3392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5856120" y="3392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5640480" y="3392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4100400" y="3571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4321080" y="35719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4541760" y="3571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4762440" y="35719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4981680" y="35719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5202360" y="35719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5421240" y="3571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5856120" y="3571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5640480" y="35719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4100400" y="375300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4321080" y="375300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4541760" y="375300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4762440" y="375300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4981680" y="375300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5202360" y="375300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5421240" y="375300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5856120" y="375300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5640480" y="375300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4100400" y="3932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4321080" y="39322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4541760" y="3932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4762440" y="3932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4981680" y="39322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5202360" y="39322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5421240" y="39322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5856120" y="39322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5640480" y="39322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3786120" y="195120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3786120" y="21319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3786120" y="230976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3786120" y="249228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3786120" y="267012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3786120" y="303048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3786120" y="321156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3786120" y="3392640"/>
            <a:ext cx="189000" cy="1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3786120" y="35719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3786120" y="375300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3786120" y="393228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4100400" y="28512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4321080" y="28512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4541760" y="28512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4762440" y="28512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4981680" y="28512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5202360" y="28512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5421240" y="28512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5856120" y="28512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5640480" y="28512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3786120" y="285120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4100400" y="1231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4321080" y="1231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4541760" y="12319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4762440" y="1231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4981680" y="12319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5202360" y="12319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5421240" y="1231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5856120" y="12319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5640480" y="12319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3684600" y="123192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15-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4248000" y="3968640"/>
            <a:ext cx="18756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4097160" y="42958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4316400" y="42958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4537080" y="429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4757760" y="429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4978440" y="4295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5197320" y="42958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5416560" y="429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5851440" y="42958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5637240" y="4295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3781440" y="429588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4097160" y="44751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4316400" y="4475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4537080" y="4475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4757760" y="4475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4978440" y="4475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5197320" y="44751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5416560" y="4475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5851440" y="447516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5637240" y="4475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3781440" y="447516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4097160" y="465624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4316400" y="46562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4537080" y="46562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4757760" y="46562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4978440" y="46562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5197320" y="46562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5416560" y="46562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5851440" y="46562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5637240" y="46562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4097160" y="483696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4316400" y="48369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4537080" y="483696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4757760" y="48369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4978440" y="4836960"/>
            <a:ext cx="18720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5197320" y="4836960"/>
            <a:ext cx="187560" cy="1098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5416560" y="483696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5851440" y="4836960"/>
            <a:ext cx="187560" cy="1098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5637240" y="4836960"/>
            <a:ext cx="18720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4097160" y="5016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4316400" y="501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4537080" y="501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4757760" y="501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4978440" y="501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5197320" y="5016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5416560" y="5016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5851440" y="5016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5637240" y="5016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4097160" y="51973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4316400" y="51973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4537080" y="51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4757760" y="51973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4978440" y="5197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5197320" y="51973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5416560" y="51973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>
            <a:off x="5851440" y="51973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5637240" y="5197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4097160" y="55166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4316400" y="55166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4537080" y="5516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4757760" y="55166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4978440" y="55166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5197320" y="55166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5416560" y="55166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5851440" y="55166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5637240" y="55166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4097160" y="56973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4316400" y="56973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4537080" y="5697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4757760" y="5697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4978440" y="56973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5197320" y="56973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5416560" y="56973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5851440" y="56973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5637240" y="56973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4097160" y="60595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>
            <a:off x="4316400" y="60595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4537080" y="60595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4757760" y="60595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4978440" y="60595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5197320" y="60595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5416560" y="60595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>
            <a:off x="5851440" y="60595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5637240" y="60595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4097160" y="623880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>
            <a:off x="4316400" y="62388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4537080" y="62388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4757760" y="62388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>
            <a:off x="4978440" y="62388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5197320" y="623880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5416560" y="62388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>
            <a:off x="5851440" y="623880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>
            <a:off x="5637240" y="62388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>
            <a:off x="4097160" y="64184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>
            <a:off x="4316400" y="64184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>
            <a:off x="4537080" y="64184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4757760" y="64184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>
            <a:off x="4978440" y="64184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5197320" y="641844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>
            <a:off x="5416560" y="64184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>
            <a:off x="5851440" y="64184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>
            <a:off x="5637240" y="64184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>
            <a:off x="4097160" y="659916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>
            <a:off x="4316400" y="6599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>
            <a:off x="4537080" y="6599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>
            <a:off x="4757760" y="6599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>
            <a:off x="4978440" y="6599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5197320" y="6599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5416560" y="6599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>
            <a:off x="5851440" y="6599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5637240" y="6599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>
            <a:off x="4097160" y="677700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4316400" y="67770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>
            <a:off x="4537080" y="67770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4757760" y="67770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>
            <a:off x="4978440" y="67770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>
            <a:off x="5197320" y="677700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>
            <a:off x="5416560" y="67770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>
            <a:off x="5851440" y="677700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5637240" y="67770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4097160" y="69595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4316400" y="69595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4537080" y="69595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4757760" y="69595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>
            <a:off x="4978440" y="69595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5197320" y="695952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5416560" y="69595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5851440" y="695952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5637240" y="69595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3781440" y="483696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>
            <a:off x="3781440" y="501660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>
            <a:off x="3781440" y="519732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>
            <a:off x="3693960" y="5516640"/>
            <a:ext cx="189000" cy="11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ts16-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>
            <a:off x="3781440" y="569736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3781440" y="60595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3781440" y="623880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3781440" y="641844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3781440" y="6599160"/>
            <a:ext cx="189000" cy="1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3781440" y="6777000"/>
            <a:ext cx="189000" cy="11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>
            <a:off x="3781440" y="695952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4097160" y="58802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4316400" y="588024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4537080" y="58802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4757760" y="588024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>
            <a:off x="4978440" y="58802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5197320" y="588024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5416560" y="588024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5851440" y="588024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5637240" y="588024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>
            <a:off x="3781440" y="588024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4097160" y="411480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>
            <a:off x="4316400" y="41148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4537080" y="41148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4757760" y="411480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4978440" y="41148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"/>
          <p:cNvSpPr/>
          <p:nvPr/>
        </p:nvSpPr>
        <p:spPr>
          <a:xfrm>
            <a:off x="5197320" y="411480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"/>
          <p:cNvSpPr/>
          <p:nvPr/>
        </p:nvSpPr>
        <p:spPr>
          <a:xfrm>
            <a:off x="5416560" y="411480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"/>
          <p:cNvSpPr/>
          <p:nvPr/>
        </p:nvSpPr>
        <p:spPr>
          <a:xfrm>
            <a:off x="5851440" y="411480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"/>
          <p:cNvSpPr/>
          <p:nvPr/>
        </p:nvSpPr>
        <p:spPr>
          <a:xfrm>
            <a:off x="5637240" y="411480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"/>
          <p:cNvSpPr/>
          <p:nvPr/>
        </p:nvSpPr>
        <p:spPr>
          <a:xfrm>
            <a:off x="3781440" y="411480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"/>
          <p:cNvSpPr/>
          <p:nvPr/>
        </p:nvSpPr>
        <p:spPr>
          <a:xfrm>
            <a:off x="3781440" y="465948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"/>
          <p:cNvSpPr/>
          <p:nvPr/>
        </p:nvSpPr>
        <p:spPr>
          <a:xfrm>
            <a:off x="4102200" y="7327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"/>
          <p:cNvSpPr/>
          <p:nvPr/>
        </p:nvSpPr>
        <p:spPr>
          <a:xfrm>
            <a:off x="4321080" y="7327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"/>
          <p:cNvSpPr/>
          <p:nvPr/>
        </p:nvSpPr>
        <p:spPr>
          <a:xfrm>
            <a:off x="4540320" y="73278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"/>
          <p:cNvSpPr/>
          <p:nvPr/>
        </p:nvSpPr>
        <p:spPr>
          <a:xfrm>
            <a:off x="4759200" y="73278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"/>
          <p:cNvSpPr/>
          <p:nvPr/>
        </p:nvSpPr>
        <p:spPr>
          <a:xfrm>
            <a:off x="4979880" y="732780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"/>
          <p:cNvSpPr/>
          <p:nvPr/>
        </p:nvSpPr>
        <p:spPr>
          <a:xfrm>
            <a:off x="5199120" y="7327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"/>
          <p:cNvSpPr/>
          <p:nvPr/>
        </p:nvSpPr>
        <p:spPr>
          <a:xfrm>
            <a:off x="5419800" y="7327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"/>
          <p:cNvSpPr/>
          <p:nvPr/>
        </p:nvSpPr>
        <p:spPr>
          <a:xfrm>
            <a:off x="5865840" y="73278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"/>
          <p:cNvSpPr/>
          <p:nvPr/>
        </p:nvSpPr>
        <p:spPr>
          <a:xfrm>
            <a:off x="5640480" y="73278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"/>
          <p:cNvSpPr/>
          <p:nvPr/>
        </p:nvSpPr>
        <p:spPr>
          <a:xfrm>
            <a:off x="3784680" y="7327800"/>
            <a:ext cx="1890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"/>
          <p:cNvSpPr/>
          <p:nvPr/>
        </p:nvSpPr>
        <p:spPr>
          <a:xfrm>
            <a:off x="4102200" y="7508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"/>
          <p:cNvSpPr/>
          <p:nvPr/>
        </p:nvSpPr>
        <p:spPr>
          <a:xfrm>
            <a:off x="4321080" y="75088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"/>
          <p:cNvSpPr/>
          <p:nvPr/>
        </p:nvSpPr>
        <p:spPr>
          <a:xfrm>
            <a:off x="4540320" y="7508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"/>
          <p:cNvSpPr/>
          <p:nvPr/>
        </p:nvSpPr>
        <p:spPr>
          <a:xfrm>
            <a:off x="4759200" y="75088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"/>
          <p:cNvSpPr/>
          <p:nvPr/>
        </p:nvSpPr>
        <p:spPr>
          <a:xfrm>
            <a:off x="4979880" y="75088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"/>
          <p:cNvSpPr/>
          <p:nvPr/>
        </p:nvSpPr>
        <p:spPr>
          <a:xfrm>
            <a:off x="5199120" y="750888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"/>
          <p:cNvSpPr/>
          <p:nvPr/>
        </p:nvSpPr>
        <p:spPr>
          <a:xfrm>
            <a:off x="5419800" y="7508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"/>
          <p:cNvSpPr/>
          <p:nvPr/>
        </p:nvSpPr>
        <p:spPr>
          <a:xfrm>
            <a:off x="5865840" y="7508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"/>
          <p:cNvSpPr/>
          <p:nvPr/>
        </p:nvSpPr>
        <p:spPr>
          <a:xfrm>
            <a:off x="5640480" y="75088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"/>
          <p:cNvSpPr/>
          <p:nvPr/>
        </p:nvSpPr>
        <p:spPr>
          <a:xfrm>
            <a:off x="3784680" y="750888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"/>
          <p:cNvSpPr/>
          <p:nvPr/>
        </p:nvSpPr>
        <p:spPr>
          <a:xfrm>
            <a:off x="4102200" y="768816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"/>
          <p:cNvSpPr/>
          <p:nvPr/>
        </p:nvSpPr>
        <p:spPr>
          <a:xfrm>
            <a:off x="4321080" y="7688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"/>
          <p:cNvSpPr/>
          <p:nvPr/>
        </p:nvSpPr>
        <p:spPr>
          <a:xfrm>
            <a:off x="4540320" y="7688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"/>
          <p:cNvSpPr/>
          <p:nvPr/>
        </p:nvSpPr>
        <p:spPr>
          <a:xfrm>
            <a:off x="4759200" y="7688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"/>
          <p:cNvSpPr/>
          <p:nvPr/>
        </p:nvSpPr>
        <p:spPr>
          <a:xfrm>
            <a:off x="4979880" y="768816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"/>
          <p:cNvSpPr/>
          <p:nvPr/>
        </p:nvSpPr>
        <p:spPr>
          <a:xfrm>
            <a:off x="5199120" y="7688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"/>
          <p:cNvSpPr/>
          <p:nvPr/>
        </p:nvSpPr>
        <p:spPr>
          <a:xfrm>
            <a:off x="5419800" y="7688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"/>
          <p:cNvSpPr/>
          <p:nvPr/>
        </p:nvSpPr>
        <p:spPr>
          <a:xfrm>
            <a:off x="5865840" y="768816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"/>
          <p:cNvSpPr/>
          <p:nvPr/>
        </p:nvSpPr>
        <p:spPr>
          <a:xfrm>
            <a:off x="5640480" y="768816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"/>
          <p:cNvSpPr/>
          <p:nvPr/>
        </p:nvSpPr>
        <p:spPr>
          <a:xfrm>
            <a:off x="3784680" y="7688160"/>
            <a:ext cx="1890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"/>
          <p:cNvSpPr/>
          <p:nvPr/>
        </p:nvSpPr>
        <p:spPr>
          <a:xfrm>
            <a:off x="4102200" y="78692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"/>
          <p:cNvSpPr/>
          <p:nvPr/>
        </p:nvSpPr>
        <p:spPr>
          <a:xfrm>
            <a:off x="4321080" y="786924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"/>
          <p:cNvSpPr/>
          <p:nvPr/>
        </p:nvSpPr>
        <p:spPr>
          <a:xfrm>
            <a:off x="4540320" y="78692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"/>
          <p:cNvSpPr/>
          <p:nvPr/>
        </p:nvSpPr>
        <p:spPr>
          <a:xfrm>
            <a:off x="4759200" y="786924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"/>
          <p:cNvSpPr/>
          <p:nvPr/>
        </p:nvSpPr>
        <p:spPr>
          <a:xfrm>
            <a:off x="4979880" y="7869240"/>
            <a:ext cx="18756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"/>
          <p:cNvSpPr/>
          <p:nvPr/>
        </p:nvSpPr>
        <p:spPr>
          <a:xfrm>
            <a:off x="5199120" y="7869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"/>
          <p:cNvSpPr/>
          <p:nvPr/>
        </p:nvSpPr>
        <p:spPr>
          <a:xfrm>
            <a:off x="5419800" y="786924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"/>
          <p:cNvSpPr/>
          <p:nvPr/>
        </p:nvSpPr>
        <p:spPr>
          <a:xfrm>
            <a:off x="5865840" y="786924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"/>
          <p:cNvSpPr/>
          <p:nvPr/>
        </p:nvSpPr>
        <p:spPr>
          <a:xfrm>
            <a:off x="5640480" y="786924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"/>
          <p:cNvSpPr/>
          <p:nvPr/>
        </p:nvSpPr>
        <p:spPr>
          <a:xfrm>
            <a:off x="4102200" y="8050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"/>
          <p:cNvSpPr/>
          <p:nvPr/>
        </p:nvSpPr>
        <p:spPr>
          <a:xfrm>
            <a:off x="4321080" y="805032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"/>
          <p:cNvSpPr/>
          <p:nvPr/>
        </p:nvSpPr>
        <p:spPr>
          <a:xfrm>
            <a:off x="4540320" y="8050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"/>
          <p:cNvSpPr/>
          <p:nvPr/>
        </p:nvSpPr>
        <p:spPr>
          <a:xfrm>
            <a:off x="4759200" y="805032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>
            <a:off x="4979880" y="805032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"/>
          <p:cNvSpPr/>
          <p:nvPr/>
        </p:nvSpPr>
        <p:spPr>
          <a:xfrm>
            <a:off x="5199120" y="8050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"/>
          <p:cNvSpPr/>
          <p:nvPr/>
        </p:nvSpPr>
        <p:spPr>
          <a:xfrm>
            <a:off x="5419800" y="805032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"/>
          <p:cNvSpPr/>
          <p:nvPr/>
        </p:nvSpPr>
        <p:spPr>
          <a:xfrm>
            <a:off x="5865840" y="805032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"/>
          <p:cNvSpPr/>
          <p:nvPr/>
        </p:nvSpPr>
        <p:spPr>
          <a:xfrm>
            <a:off x="5640480" y="805032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"/>
          <p:cNvSpPr/>
          <p:nvPr/>
        </p:nvSpPr>
        <p:spPr>
          <a:xfrm>
            <a:off x="4102200" y="8229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"/>
          <p:cNvSpPr/>
          <p:nvPr/>
        </p:nvSpPr>
        <p:spPr>
          <a:xfrm>
            <a:off x="4321080" y="8229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"/>
          <p:cNvSpPr/>
          <p:nvPr/>
        </p:nvSpPr>
        <p:spPr>
          <a:xfrm>
            <a:off x="4540320" y="8229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"/>
          <p:cNvSpPr/>
          <p:nvPr/>
        </p:nvSpPr>
        <p:spPr>
          <a:xfrm>
            <a:off x="4759200" y="822960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"/>
          <p:cNvSpPr/>
          <p:nvPr/>
        </p:nvSpPr>
        <p:spPr>
          <a:xfrm>
            <a:off x="4979880" y="822960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"/>
          <p:cNvSpPr/>
          <p:nvPr/>
        </p:nvSpPr>
        <p:spPr>
          <a:xfrm>
            <a:off x="5199120" y="8229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"/>
          <p:cNvSpPr/>
          <p:nvPr/>
        </p:nvSpPr>
        <p:spPr>
          <a:xfrm>
            <a:off x="5419800" y="822960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"/>
          <p:cNvSpPr/>
          <p:nvPr/>
        </p:nvSpPr>
        <p:spPr>
          <a:xfrm>
            <a:off x="5865840" y="822960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"/>
          <p:cNvSpPr/>
          <p:nvPr/>
        </p:nvSpPr>
        <p:spPr>
          <a:xfrm>
            <a:off x="5640480" y="822960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"/>
          <p:cNvSpPr/>
          <p:nvPr/>
        </p:nvSpPr>
        <p:spPr>
          <a:xfrm>
            <a:off x="4102200" y="84106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"/>
          <p:cNvSpPr/>
          <p:nvPr/>
        </p:nvSpPr>
        <p:spPr>
          <a:xfrm>
            <a:off x="4321080" y="841068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"/>
          <p:cNvSpPr/>
          <p:nvPr/>
        </p:nvSpPr>
        <p:spPr>
          <a:xfrm>
            <a:off x="4540320" y="84106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"/>
          <p:cNvSpPr/>
          <p:nvPr/>
        </p:nvSpPr>
        <p:spPr>
          <a:xfrm>
            <a:off x="4759200" y="841068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"/>
          <p:cNvSpPr/>
          <p:nvPr/>
        </p:nvSpPr>
        <p:spPr>
          <a:xfrm>
            <a:off x="4979880" y="8410680"/>
            <a:ext cx="18756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"/>
          <p:cNvSpPr/>
          <p:nvPr/>
        </p:nvSpPr>
        <p:spPr>
          <a:xfrm>
            <a:off x="5199120" y="84106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"/>
          <p:cNvSpPr/>
          <p:nvPr/>
        </p:nvSpPr>
        <p:spPr>
          <a:xfrm>
            <a:off x="5419800" y="84106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"/>
          <p:cNvSpPr/>
          <p:nvPr/>
        </p:nvSpPr>
        <p:spPr>
          <a:xfrm>
            <a:off x="5865840" y="841068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"/>
          <p:cNvSpPr/>
          <p:nvPr/>
        </p:nvSpPr>
        <p:spPr>
          <a:xfrm>
            <a:off x="5640480" y="841068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"/>
          <p:cNvSpPr/>
          <p:nvPr/>
        </p:nvSpPr>
        <p:spPr>
          <a:xfrm>
            <a:off x="4102200" y="858852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"/>
          <p:cNvSpPr/>
          <p:nvPr/>
        </p:nvSpPr>
        <p:spPr>
          <a:xfrm>
            <a:off x="4321080" y="858852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"/>
          <p:cNvSpPr/>
          <p:nvPr/>
        </p:nvSpPr>
        <p:spPr>
          <a:xfrm>
            <a:off x="4540320" y="858852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"/>
          <p:cNvSpPr/>
          <p:nvPr/>
        </p:nvSpPr>
        <p:spPr>
          <a:xfrm>
            <a:off x="4759200" y="858852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"/>
          <p:cNvSpPr/>
          <p:nvPr/>
        </p:nvSpPr>
        <p:spPr>
          <a:xfrm>
            <a:off x="4979880" y="8588520"/>
            <a:ext cx="18756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"/>
          <p:cNvSpPr/>
          <p:nvPr/>
        </p:nvSpPr>
        <p:spPr>
          <a:xfrm>
            <a:off x="5199120" y="858852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"/>
          <p:cNvSpPr/>
          <p:nvPr/>
        </p:nvSpPr>
        <p:spPr>
          <a:xfrm>
            <a:off x="5419800" y="858852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"/>
          <p:cNvSpPr/>
          <p:nvPr/>
        </p:nvSpPr>
        <p:spPr>
          <a:xfrm>
            <a:off x="5865840" y="858852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"/>
          <p:cNvSpPr/>
          <p:nvPr/>
        </p:nvSpPr>
        <p:spPr>
          <a:xfrm>
            <a:off x="5640480" y="858852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"/>
          <p:cNvSpPr/>
          <p:nvPr/>
        </p:nvSpPr>
        <p:spPr>
          <a:xfrm>
            <a:off x="4102200" y="894888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"/>
          <p:cNvSpPr/>
          <p:nvPr/>
        </p:nvSpPr>
        <p:spPr>
          <a:xfrm>
            <a:off x="4321080" y="8948880"/>
            <a:ext cx="18756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"/>
          <p:cNvSpPr/>
          <p:nvPr/>
        </p:nvSpPr>
        <p:spPr>
          <a:xfrm>
            <a:off x="4540320" y="8948880"/>
            <a:ext cx="187200" cy="1076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"/>
          <p:cNvSpPr/>
          <p:nvPr/>
        </p:nvSpPr>
        <p:spPr>
          <a:xfrm>
            <a:off x="4759200" y="894888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"/>
          <p:cNvSpPr/>
          <p:nvPr/>
        </p:nvSpPr>
        <p:spPr>
          <a:xfrm>
            <a:off x="4979880" y="8948880"/>
            <a:ext cx="18756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"/>
          <p:cNvSpPr/>
          <p:nvPr/>
        </p:nvSpPr>
        <p:spPr>
          <a:xfrm>
            <a:off x="5199120" y="894888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"/>
          <p:cNvSpPr/>
          <p:nvPr/>
        </p:nvSpPr>
        <p:spPr>
          <a:xfrm>
            <a:off x="5419800" y="894888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"/>
          <p:cNvSpPr/>
          <p:nvPr/>
        </p:nvSpPr>
        <p:spPr>
          <a:xfrm>
            <a:off x="5865840" y="8948880"/>
            <a:ext cx="187200" cy="1076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"/>
          <p:cNvSpPr/>
          <p:nvPr/>
        </p:nvSpPr>
        <p:spPr>
          <a:xfrm>
            <a:off x="5640480" y="8948880"/>
            <a:ext cx="187200" cy="107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"/>
          <p:cNvSpPr/>
          <p:nvPr/>
        </p:nvSpPr>
        <p:spPr>
          <a:xfrm>
            <a:off x="3784680" y="786924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"/>
          <p:cNvSpPr/>
          <p:nvPr/>
        </p:nvSpPr>
        <p:spPr>
          <a:xfrm>
            <a:off x="3784680" y="805032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"/>
          <p:cNvSpPr/>
          <p:nvPr/>
        </p:nvSpPr>
        <p:spPr>
          <a:xfrm>
            <a:off x="3784680" y="822960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"/>
          <p:cNvSpPr/>
          <p:nvPr/>
        </p:nvSpPr>
        <p:spPr>
          <a:xfrm>
            <a:off x="3784680" y="841068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"/>
          <p:cNvSpPr/>
          <p:nvPr/>
        </p:nvSpPr>
        <p:spPr>
          <a:xfrm>
            <a:off x="3784680" y="8588520"/>
            <a:ext cx="189000" cy="11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"/>
          <p:cNvSpPr/>
          <p:nvPr/>
        </p:nvSpPr>
        <p:spPr>
          <a:xfrm>
            <a:off x="3784680" y="8948880"/>
            <a:ext cx="1890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"/>
          <p:cNvSpPr/>
          <p:nvPr/>
        </p:nvSpPr>
        <p:spPr>
          <a:xfrm>
            <a:off x="4102200" y="87710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"/>
          <p:cNvSpPr/>
          <p:nvPr/>
        </p:nvSpPr>
        <p:spPr>
          <a:xfrm>
            <a:off x="4321080" y="87710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"/>
          <p:cNvSpPr/>
          <p:nvPr/>
        </p:nvSpPr>
        <p:spPr>
          <a:xfrm>
            <a:off x="4540320" y="8771040"/>
            <a:ext cx="187200" cy="10800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"/>
          <p:cNvSpPr/>
          <p:nvPr/>
        </p:nvSpPr>
        <p:spPr>
          <a:xfrm>
            <a:off x="4759200" y="8771040"/>
            <a:ext cx="18756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"/>
          <p:cNvSpPr/>
          <p:nvPr/>
        </p:nvSpPr>
        <p:spPr>
          <a:xfrm>
            <a:off x="4979880" y="8771040"/>
            <a:ext cx="18756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"/>
          <p:cNvSpPr/>
          <p:nvPr/>
        </p:nvSpPr>
        <p:spPr>
          <a:xfrm>
            <a:off x="5199120" y="87710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"/>
          <p:cNvSpPr/>
          <p:nvPr/>
        </p:nvSpPr>
        <p:spPr>
          <a:xfrm>
            <a:off x="5419800" y="87710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"/>
          <p:cNvSpPr/>
          <p:nvPr/>
        </p:nvSpPr>
        <p:spPr>
          <a:xfrm>
            <a:off x="5865840" y="8771040"/>
            <a:ext cx="187200" cy="1080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"/>
          <p:cNvSpPr/>
          <p:nvPr/>
        </p:nvSpPr>
        <p:spPr>
          <a:xfrm>
            <a:off x="5640480" y="8771040"/>
            <a:ext cx="187200" cy="10800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"/>
          <p:cNvSpPr/>
          <p:nvPr/>
        </p:nvSpPr>
        <p:spPr>
          <a:xfrm>
            <a:off x="3784680" y="8771040"/>
            <a:ext cx="189000" cy="1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4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"/>
          <p:cNvSpPr/>
          <p:nvPr/>
        </p:nvSpPr>
        <p:spPr>
          <a:xfrm>
            <a:off x="4102200" y="71485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"/>
          <p:cNvSpPr/>
          <p:nvPr/>
        </p:nvSpPr>
        <p:spPr>
          <a:xfrm>
            <a:off x="4321080" y="714852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"/>
          <p:cNvSpPr/>
          <p:nvPr/>
        </p:nvSpPr>
        <p:spPr>
          <a:xfrm>
            <a:off x="4540320" y="71485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"/>
          <p:cNvSpPr/>
          <p:nvPr/>
        </p:nvSpPr>
        <p:spPr>
          <a:xfrm>
            <a:off x="4759200" y="7148520"/>
            <a:ext cx="18756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"/>
          <p:cNvSpPr/>
          <p:nvPr/>
        </p:nvSpPr>
        <p:spPr>
          <a:xfrm>
            <a:off x="4979880" y="7148520"/>
            <a:ext cx="18756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"/>
          <p:cNvSpPr/>
          <p:nvPr/>
        </p:nvSpPr>
        <p:spPr>
          <a:xfrm>
            <a:off x="5199120" y="71485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"/>
          <p:cNvSpPr/>
          <p:nvPr/>
        </p:nvSpPr>
        <p:spPr>
          <a:xfrm>
            <a:off x="5419800" y="7148520"/>
            <a:ext cx="187200" cy="109440"/>
          </a:xfrm>
          <a:prstGeom prst="rect">
            <a:avLst/>
          </a:prstGeom>
          <a:solidFill>
            <a:srgbClr val="93e77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C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"/>
          <p:cNvSpPr/>
          <p:nvPr/>
        </p:nvSpPr>
        <p:spPr>
          <a:xfrm>
            <a:off x="5865840" y="7148520"/>
            <a:ext cx="18720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A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"/>
          <p:cNvSpPr/>
          <p:nvPr/>
        </p:nvSpPr>
        <p:spPr>
          <a:xfrm>
            <a:off x="5640480" y="7148520"/>
            <a:ext cx="187200" cy="109440"/>
          </a:xfrm>
          <a:prstGeom prst="rect">
            <a:avLst/>
          </a:prstGeom>
          <a:solidFill>
            <a:srgbClr val="f7656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BC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"/>
          <p:cNvSpPr/>
          <p:nvPr/>
        </p:nvSpPr>
        <p:spPr>
          <a:xfrm>
            <a:off x="3784680" y="7148520"/>
            <a:ext cx="189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"/>
          <p:cNvSpPr/>
          <p:nvPr/>
        </p:nvSpPr>
        <p:spPr>
          <a:xfrm>
            <a:off x="2224800" y="542880"/>
            <a:ext cx="25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Arial"/>
              </a:rPr>
              <a:t>Sequenced trypsinogen constru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7T12:50:53Z</dcterms:created>
  <dc:creator>icsym</dc:creator>
  <dc:description/>
  <dc:language>en-US</dc:language>
  <cp:lastModifiedBy>icsym</cp:lastModifiedBy>
  <dcterms:modified xsi:type="dcterms:W3CDTF">2009-04-22T20:13:07Z</dcterms:modified>
  <cp:revision>20</cp:revision>
  <dc:subject/>
  <dc:title>Slide 1</dc:title>
</cp:coreProperties>
</file>